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1.xml" ContentType="application/vnd.openxmlformats-officedocument.presentationml.notesSl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7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8.xml" ContentType="application/vnd.openxmlformats-officedocument.drawingml.chart+xml"/>
  <Override PartName="/ppt/drawings/drawing3.xml" ContentType="application/vnd.openxmlformats-officedocument.drawingml.chartshapes+xml"/>
  <Override PartName="/ppt/charts/chart9.xml" ContentType="application/vnd.openxmlformats-officedocument.drawingml.chart+xml"/>
  <Override PartName="/ppt/drawings/drawing4.xml" ContentType="application/vnd.openxmlformats-officedocument.drawingml.chartshapes+xml"/>
  <Override PartName="/ppt/charts/chart10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7" r:id="rId2"/>
    <p:sldId id="270" r:id="rId3"/>
    <p:sldId id="275" r:id="rId4"/>
    <p:sldId id="277" r:id="rId5"/>
    <p:sldId id="299" r:id="rId6"/>
    <p:sldId id="285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3"/>
    <p:restoredTop sz="94663"/>
  </p:normalViewPr>
  <p:slideViewPr>
    <p:cSldViewPr snapToGrid="0" snapToObjects="1">
      <p:cViewPr varScale="1">
        <p:scale>
          <a:sx n="112" d="100"/>
          <a:sy n="112" d="100"/>
        </p:scale>
        <p:origin x="1440" y="2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Workbook2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Macintosh%20HD:Users:devyfirenagarna:Dropbox:dropbox:Thesis:chapter%205%20the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evyfirenagarna:Desktop:backupdropbox%2029012018:dropbox:Thesis:chapter%204%20charcter%20GFs:mini%20chapter%20GFprimary%20vs%20GFCL%202%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evyfirenagarna:Desktop:backupdropbox%2029012018:dropbox:Thesis:chapter%204%20charcter%20GFs:mini%20chapter%20GFprimary%20vs%20GFCL%202%2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evyfirenagarna:Desktop:backupdropbox%2029012018:dropbox:Thesis:chapter%204%20charcter%20GFs:mini%20chapter%20GFprimary%20vs%20GFCL%202%20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evyfirenagarna:Desktop:backupdropbox%2029012018:dropbox:Thesis:chapter%204%20charcter%20GFs:mini%20chapter%20GFprimary%20vs%20GFCL%202%20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Macintosh%20HD:Users:devyfirenagarna:Dropbox:dropbox:paper:devy%20QPCR%20REPEATING%20CO%20CULTURE%20.xlsx" TargetMode="External"/><Relationship Id="rId1" Type="http://schemas.openxmlformats.org/officeDocument/2006/relationships/themeOverride" Target="../theme/themeOverride1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Macintosh%20HD:Users:devyfirenagarna:Dropbox:dropbox:paper:devy%20QPCR%20REPEATING%20CO%20CULTURE%20.xlsx" TargetMode="External"/><Relationship Id="rId1" Type="http://schemas.openxmlformats.org/officeDocument/2006/relationships/themeOverride" Target="../theme/themeOverride2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Macintosh%20HD:Users:devyfirenagarna:Desktop:backupdropbox%2029012018:dropbox:Thesis:chapter%205:chapter%205%20co%20cult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Macintosh%20HD:Users:devyfirenagarna:Desktop:Folder%20%20only:backupdropbox%2029012018:dropbox:Thesis:chapter%205:chapter%205%20co%20cul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Periostin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A6A6A6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95000"/>
                  <a:lumOff val="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1-DF94-49C3-93B6-E7BDF679F602}"/>
              </c:ext>
            </c:extLst>
          </c:dPt>
          <c:dPt>
            <c:idx val="2"/>
            <c:invertIfNegative val="0"/>
            <c:bubble3D val="0"/>
            <c:spPr>
              <a:solidFill>
                <a:srgbClr val="D9D9D9"/>
              </a:solidFill>
            </c:spPr>
            <c:extLst>
              <c:ext xmlns:c16="http://schemas.microsoft.com/office/drawing/2014/chart" uri="{C3380CC4-5D6E-409C-BE32-E72D297353CC}">
                <c16:uniqueId val="{00000003-DF94-49C3-93B6-E7BDF679F602}"/>
              </c:ext>
            </c:extLst>
          </c:dPt>
          <c:errBars>
            <c:errBarType val="plus"/>
            <c:errValType val="cust"/>
            <c:noEndCap val="0"/>
            <c:plus>
              <c:numRef>
                <c:f>'[mini chapter GFprimary vs GFCL 2 .xlsx]Periostin CM GF Primary vs CL'!$AB$153:$AB$156</c:f>
                <c:numCache>
                  <c:formatCode>General</c:formatCode>
                  <c:ptCount val="4"/>
                  <c:pt idx="0">
                    <c:v>0.65114405070154202</c:v>
                  </c:pt>
                  <c:pt idx="1">
                    <c:v>5.0274000392922999E-2</c:v>
                  </c:pt>
                  <c:pt idx="2">
                    <c:v>0.123825143975916</c:v>
                  </c:pt>
                  <c:pt idx="3">
                    <c:v>1.3060719429959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mini chapter GFprimary vs GFCL 2 .xlsx]Periostin CM GF Primary vs CL'!$Z$153:$Z$156</c:f>
              <c:strCache>
                <c:ptCount val="4"/>
                <c:pt idx="0">
                  <c:v>GF1</c:v>
                </c:pt>
                <c:pt idx="1">
                  <c:v>GF2</c:v>
                </c:pt>
                <c:pt idx="2">
                  <c:v>GF3</c:v>
                </c:pt>
                <c:pt idx="3">
                  <c:v>GF4</c:v>
                </c:pt>
              </c:strCache>
            </c:strRef>
          </c:cat>
          <c:val>
            <c:numRef>
              <c:f>'[mini chapter GFprimary vs GFCL 2 .xlsx]Periostin CM GF Primary vs CL'!$AA$153:$AA$156</c:f>
              <c:numCache>
                <c:formatCode>General</c:formatCode>
                <c:ptCount val="4"/>
                <c:pt idx="0">
                  <c:v>2.6977075111334332</c:v>
                </c:pt>
                <c:pt idx="1">
                  <c:v>0.25581404930368101</c:v>
                </c:pt>
                <c:pt idx="2">
                  <c:v>0.48553165548666599</c:v>
                </c:pt>
                <c:pt idx="3">
                  <c:v>2.68678577662684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F94-49C3-93B6-E7BDF679F6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9569896"/>
        <c:axId val="549575416"/>
      </c:barChart>
      <c:catAx>
        <c:axId val="5495698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Normal media (3 days)</a:t>
                </a:r>
              </a:p>
            </c:rich>
          </c:tx>
          <c:overlay val="0"/>
        </c:title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575416"/>
        <c:crosses val="autoZero"/>
        <c:auto val="1"/>
        <c:lblAlgn val="ctr"/>
        <c:lblOffset val="100"/>
        <c:noMultiLvlLbl val="0"/>
      </c:catAx>
      <c:valAx>
        <c:axId val="5495754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Relative</a:t>
                </a:r>
                <a:r>
                  <a:rPr lang="en-US" sz="1200" baseline="0"/>
                  <a:t> expression</a:t>
                </a:r>
                <a:endParaRPr lang="en-US" sz="120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5698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1037312627981"/>
          <c:y val="0.16798962189217601"/>
          <c:w val="0.84048396886017096"/>
          <c:h val="0.4980074748271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LP staining'!$M$4</c:f>
              <c:strCache>
                <c:ptCount val="1"/>
                <c:pt idx="0">
                  <c:v>O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'ALP staining'!$O$5:$O$7</c:f>
                <c:numCache>
                  <c:formatCode>General</c:formatCode>
                  <c:ptCount val="3"/>
                  <c:pt idx="0">
                    <c:v>1.9640943629741101E-2</c:v>
                  </c:pt>
                  <c:pt idx="1">
                    <c:v>2.5177370792042301E-2</c:v>
                  </c:pt>
                  <c:pt idx="2">
                    <c:v>4.9244289008980504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ALP staining'!$L$5:$L$7</c:f>
              <c:strCache>
                <c:ptCount val="3"/>
                <c:pt idx="0">
                  <c:v>Direct co culture PDLSC-GFs(1:3)</c:v>
                </c:pt>
                <c:pt idx="1">
                  <c:v>PDL only</c:v>
                </c:pt>
                <c:pt idx="2">
                  <c:v>GF only</c:v>
                </c:pt>
              </c:strCache>
            </c:strRef>
          </c:cat>
          <c:val>
            <c:numRef>
              <c:f>'ALP staining'!$M$5:$M$7</c:f>
              <c:numCache>
                <c:formatCode>General</c:formatCode>
                <c:ptCount val="3"/>
                <c:pt idx="0">
                  <c:v>0.25316666666666698</c:v>
                </c:pt>
                <c:pt idx="1">
                  <c:v>0.2215</c:v>
                </c:pt>
                <c:pt idx="2">
                  <c:v>0.17474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5F-4C32-BEEA-C3BCDB466E1B}"/>
            </c:ext>
          </c:extLst>
        </c:ser>
        <c:ser>
          <c:idx val="1"/>
          <c:order val="1"/>
          <c:tx>
            <c:strRef>
              <c:f>'ALP staining'!$N$4</c:f>
              <c:strCache>
                <c:ptCount val="1"/>
                <c:pt idx="0">
                  <c:v>NM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plus"/>
            <c:errValType val="cust"/>
            <c:noEndCap val="0"/>
            <c:plus>
              <c:numRef>
                <c:f>'[4]ALP staining'!$P$5:$P$7</c:f>
                <c:numCache>
                  <c:formatCode>General</c:formatCode>
                  <c:ptCount val="3"/>
                  <c:pt idx="0">
                    <c:v>1.6244999230532398E-2</c:v>
                  </c:pt>
                  <c:pt idx="1">
                    <c:v>1.6476245527020601E-2</c:v>
                  </c:pt>
                  <c:pt idx="2">
                    <c:v>3.7859388972001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ALP staining'!$L$5:$L$7</c:f>
              <c:strCache>
                <c:ptCount val="3"/>
                <c:pt idx="0">
                  <c:v>Direct co culture PDLSC-GFs(1:3)</c:v>
                </c:pt>
                <c:pt idx="1">
                  <c:v>PDL only</c:v>
                </c:pt>
                <c:pt idx="2">
                  <c:v>GF only</c:v>
                </c:pt>
              </c:strCache>
            </c:strRef>
          </c:cat>
          <c:val>
            <c:numRef>
              <c:f>'ALP staining'!$N$5:$N$7</c:f>
              <c:numCache>
                <c:formatCode>General</c:formatCode>
                <c:ptCount val="3"/>
                <c:pt idx="0">
                  <c:v>7.7499999999999999E-2</c:v>
                </c:pt>
                <c:pt idx="1">
                  <c:v>4.7666666666666697E-2</c:v>
                </c:pt>
                <c:pt idx="2">
                  <c:v>5.85000000000000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75F-4C32-BEEA-C3BCDB466E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3505096"/>
        <c:axId val="543499336"/>
      </c:barChart>
      <c:catAx>
        <c:axId val="54350509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3499336"/>
        <c:crosses val="autoZero"/>
        <c:auto val="1"/>
        <c:lblAlgn val="ctr"/>
        <c:lblOffset val="100"/>
        <c:noMultiLvlLbl val="0"/>
      </c:catAx>
      <c:valAx>
        <c:axId val="5434993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OD</a:t>
                </a:r>
                <a:r>
                  <a:rPr lang="en-US" sz="1400" baseline="0"/>
                  <a:t> 405 nm</a:t>
                </a:r>
                <a:endParaRPr lang="en-US" sz="14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3505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 err="1"/>
              <a:t>Asporin</a:t>
            </a:r>
            <a:endParaRPr lang="en-US" sz="1400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A6A6A6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0D0D0D"/>
              </a:solidFill>
            </c:spPr>
            <c:extLst>
              <c:ext xmlns:c16="http://schemas.microsoft.com/office/drawing/2014/chart" uri="{C3380CC4-5D6E-409C-BE32-E72D297353CC}">
                <c16:uniqueId val="{00000001-C976-4D42-9FAE-DED15021CDFA}"/>
              </c:ext>
            </c:extLst>
          </c:dPt>
          <c:dPt>
            <c:idx val="2"/>
            <c:invertIfNegative val="0"/>
            <c:bubble3D val="0"/>
            <c:spPr>
              <a:solidFill>
                <a:srgbClr val="D9D9D9"/>
              </a:solidFill>
            </c:spPr>
            <c:extLst>
              <c:ext xmlns:c16="http://schemas.microsoft.com/office/drawing/2014/chart" uri="{C3380CC4-5D6E-409C-BE32-E72D297353CC}">
                <c16:uniqueId val="{00000003-C976-4D42-9FAE-DED15021CDFA}"/>
              </c:ext>
            </c:extLst>
          </c:dPt>
          <c:errBars>
            <c:errBarType val="plus"/>
            <c:errValType val="cust"/>
            <c:noEndCap val="0"/>
            <c:plus>
              <c:numRef>
                <c:f>'CM GF Primary vs CL PLAP'!$AB$157:$AB$160</c:f>
                <c:numCache>
                  <c:formatCode>General</c:formatCode>
                  <c:ptCount val="4"/>
                  <c:pt idx="0">
                    <c:v>1.1677487182032671</c:v>
                  </c:pt>
                  <c:pt idx="1">
                    <c:v>13.281180181763069</c:v>
                  </c:pt>
                  <c:pt idx="2">
                    <c:v>8.5431595392670499</c:v>
                  </c:pt>
                  <c:pt idx="3">
                    <c:v>3.850267346126389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CM GF Primary vs CL PLAP'!$Z$157:$Z$160</c:f>
              <c:strCache>
                <c:ptCount val="4"/>
                <c:pt idx="0">
                  <c:v>GF1</c:v>
                </c:pt>
                <c:pt idx="1">
                  <c:v>GF2</c:v>
                </c:pt>
                <c:pt idx="2">
                  <c:v>GF3</c:v>
                </c:pt>
                <c:pt idx="3">
                  <c:v>GF4</c:v>
                </c:pt>
              </c:strCache>
            </c:strRef>
          </c:cat>
          <c:val>
            <c:numRef>
              <c:f>'CM GF Primary vs CL PLAP'!$AA$157:$AA$160</c:f>
              <c:numCache>
                <c:formatCode>General</c:formatCode>
                <c:ptCount val="4"/>
                <c:pt idx="0">
                  <c:v>4.8717647407377056</c:v>
                </c:pt>
                <c:pt idx="1">
                  <c:v>23.09397270390528</c:v>
                </c:pt>
                <c:pt idx="2">
                  <c:v>7.2207509633073714</c:v>
                </c:pt>
                <c:pt idx="3">
                  <c:v>4.618143091618869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976-4D42-9FAE-DED15021CD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9605768"/>
        <c:axId val="549611336"/>
      </c:barChart>
      <c:catAx>
        <c:axId val="5496057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Normal media (3 days)</a:t>
                </a:r>
              </a:p>
            </c:rich>
          </c:tx>
          <c:overlay val="0"/>
        </c:title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611336"/>
        <c:crosses val="autoZero"/>
        <c:auto val="1"/>
        <c:lblAlgn val="ctr"/>
        <c:lblOffset val="100"/>
        <c:noMultiLvlLbl val="0"/>
      </c:catAx>
      <c:valAx>
        <c:axId val="54961133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Relative</a:t>
                </a:r>
                <a:r>
                  <a:rPr lang="en-US" sz="1200" baseline="0"/>
                  <a:t> expression</a:t>
                </a:r>
                <a:endParaRPr lang="en-US" sz="120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6057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Nestin 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A6A6A6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0D0D0D"/>
              </a:solidFill>
            </c:spPr>
            <c:extLst>
              <c:ext xmlns:c16="http://schemas.microsoft.com/office/drawing/2014/chart" uri="{C3380CC4-5D6E-409C-BE32-E72D297353CC}">
                <c16:uniqueId val="{00000001-D215-4A74-B632-7337A1B88A75}"/>
              </c:ext>
            </c:extLst>
          </c:dPt>
          <c:dPt>
            <c:idx val="2"/>
            <c:invertIfNegative val="0"/>
            <c:bubble3D val="0"/>
            <c:spPr>
              <a:solidFill>
                <a:srgbClr val="D9D9D9"/>
              </a:solidFill>
            </c:spPr>
            <c:extLst>
              <c:ext xmlns:c16="http://schemas.microsoft.com/office/drawing/2014/chart" uri="{C3380CC4-5D6E-409C-BE32-E72D297353CC}">
                <c16:uniqueId val="{00000003-D215-4A74-B632-7337A1B88A7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D215-4A74-B632-7337A1B88A75}"/>
              </c:ext>
            </c:extLst>
          </c:dPt>
          <c:errBars>
            <c:errBarType val="plus"/>
            <c:errValType val="cust"/>
            <c:noEndCap val="0"/>
            <c:plus>
              <c:numRef>
                <c:f>'Nestin CM GF Primary vs CL'!$AC$156:$AC$159</c:f>
                <c:numCache>
                  <c:formatCode>General</c:formatCode>
                  <c:ptCount val="4"/>
                  <c:pt idx="0">
                    <c:v>3.1927363665988702E-2</c:v>
                  </c:pt>
                  <c:pt idx="1">
                    <c:v>5.0424106595281397E-2</c:v>
                  </c:pt>
                  <c:pt idx="2">
                    <c:v>0.34407832417940298</c:v>
                  </c:pt>
                  <c:pt idx="3">
                    <c:v>0.1651992396381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Nestin CM GF Primary vs CL'!$AA$156:$AA$159</c:f>
              <c:strCache>
                <c:ptCount val="4"/>
                <c:pt idx="0">
                  <c:v>GF1</c:v>
                </c:pt>
                <c:pt idx="1">
                  <c:v>GF2</c:v>
                </c:pt>
                <c:pt idx="2">
                  <c:v>GF3</c:v>
                </c:pt>
                <c:pt idx="3">
                  <c:v>GF4</c:v>
                </c:pt>
              </c:strCache>
            </c:strRef>
          </c:cat>
          <c:val>
            <c:numRef>
              <c:f>'Nestin CM GF Primary vs CL'!$AB$156:$AB$159</c:f>
              <c:numCache>
                <c:formatCode>General</c:formatCode>
                <c:ptCount val="4"/>
                <c:pt idx="0">
                  <c:v>9.3768051495486102E-2</c:v>
                </c:pt>
                <c:pt idx="1">
                  <c:v>5.7947081766620299E-2</c:v>
                </c:pt>
                <c:pt idx="2">
                  <c:v>0.58005964717105896</c:v>
                </c:pt>
                <c:pt idx="3">
                  <c:v>0.2845558758972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215-4A74-B632-7337A1B88A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9651608"/>
        <c:axId val="549657160"/>
      </c:barChart>
      <c:catAx>
        <c:axId val="5496516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Normal media (3 days)</a:t>
                </a:r>
              </a:p>
            </c:rich>
          </c:tx>
          <c:overlay val="0"/>
        </c:title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657160"/>
        <c:crosses val="autoZero"/>
        <c:auto val="1"/>
        <c:lblAlgn val="ctr"/>
        <c:lblOffset val="100"/>
        <c:noMultiLvlLbl val="0"/>
      </c:catAx>
      <c:valAx>
        <c:axId val="5496571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Relative</a:t>
                </a:r>
                <a:r>
                  <a:rPr lang="en-US" sz="1200" baseline="0"/>
                  <a:t> expression</a:t>
                </a:r>
                <a:endParaRPr lang="en-US" sz="120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6516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dirty="0"/>
              <a:t>ALP activity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A6A6A6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0D0D0D"/>
              </a:solidFill>
            </c:spPr>
            <c:extLst>
              <c:ext xmlns:c16="http://schemas.microsoft.com/office/drawing/2014/chart" uri="{C3380CC4-5D6E-409C-BE32-E72D297353CC}">
                <c16:uniqueId val="{00000001-F64B-43E1-81AD-807CB849FD89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F64B-43E1-81AD-807CB849FD89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F64B-43E1-81AD-807CB849FD89}"/>
              </c:ext>
            </c:extLst>
          </c:dPt>
          <c:errBars>
            <c:errBarType val="plus"/>
            <c:errValType val="cust"/>
            <c:noEndCap val="0"/>
            <c:plus>
              <c:numRef>
                <c:f>'ALP activity 2'!$E$53:$E$58</c:f>
                <c:numCache>
                  <c:formatCode>General</c:formatCode>
                  <c:ptCount val="6"/>
                  <c:pt idx="0">
                    <c:v>1.8806197693473199E-2</c:v>
                  </c:pt>
                  <c:pt idx="1">
                    <c:v>8.6180824464644298E-2</c:v>
                  </c:pt>
                  <c:pt idx="2">
                    <c:v>0.68863986789564702</c:v>
                  </c:pt>
                  <c:pt idx="3">
                    <c:v>0.20494986709927401</c:v>
                  </c:pt>
                  <c:pt idx="4">
                    <c:v>0.998457113242191</c:v>
                  </c:pt>
                  <c:pt idx="5">
                    <c:v>0.2340696574788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ALP activity 2'!$C$53:$C$58</c:f>
              <c:strCache>
                <c:ptCount val="6"/>
                <c:pt idx="0">
                  <c:v>GFs1</c:v>
                </c:pt>
                <c:pt idx="1">
                  <c:v>GFs2</c:v>
                </c:pt>
                <c:pt idx="2">
                  <c:v>GF3</c:v>
                </c:pt>
                <c:pt idx="3">
                  <c:v>GF4</c:v>
                </c:pt>
                <c:pt idx="4">
                  <c:v>HOS (positive control)</c:v>
                </c:pt>
                <c:pt idx="5">
                  <c:v>HUVEC (negative control)</c:v>
                </c:pt>
              </c:strCache>
            </c:strRef>
          </c:cat>
          <c:val>
            <c:numRef>
              <c:f>'ALP activity 2'!$D$53:$D$58</c:f>
              <c:numCache>
                <c:formatCode>General</c:formatCode>
                <c:ptCount val="6"/>
                <c:pt idx="0">
                  <c:v>0.53528773072747005</c:v>
                </c:pt>
                <c:pt idx="1">
                  <c:v>0.45928338762214999</c:v>
                </c:pt>
                <c:pt idx="2">
                  <c:v>3.3803420000000002</c:v>
                </c:pt>
                <c:pt idx="3">
                  <c:v>0.21794854999999999</c:v>
                </c:pt>
                <c:pt idx="4">
                  <c:v>16.137878749999999</c:v>
                </c:pt>
                <c:pt idx="5">
                  <c:v>0.5598290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64B-43E1-81AD-807CB849FD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9707688"/>
        <c:axId val="549713208"/>
      </c:barChart>
      <c:catAx>
        <c:axId val="5497076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Normal media (3 days)</a:t>
                </a:r>
              </a:p>
            </c:rich>
          </c:tx>
          <c:overlay val="0"/>
        </c:title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713208"/>
        <c:crosses val="autoZero"/>
        <c:auto val="1"/>
        <c:lblAlgn val="ctr"/>
        <c:lblOffset val="100"/>
        <c:noMultiLvlLbl val="0"/>
      </c:catAx>
      <c:valAx>
        <c:axId val="54971320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ALP</a:t>
                </a:r>
                <a:r>
                  <a:rPr lang="en-US" sz="1200" baseline="0"/>
                  <a:t> conentration in microgram/mL</a:t>
                </a:r>
                <a:endParaRPr lang="en-US" sz="1200"/>
              </a:p>
            </c:rich>
          </c:tx>
          <c:layout>
            <c:manualLayout>
              <c:xMode val="edge"/>
              <c:yMode val="edge"/>
              <c:x val="1.55297123159201E-2"/>
              <c:y val="7.2222256078362093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7076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dirty="0"/>
              <a:t>ALP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A6A6A6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0D0D0D"/>
              </a:solidFill>
            </c:spPr>
            <c:extLst>
              <c:ext xmlns:c16="http://schemas.microsoft.com/office/drawing/2014/chart" uri="{C3380CC4-5D6E-409C-BE32-E72D297353CC}">
                <c16:uniqueId val="{00000001-51EC-443B-B6BE-4CF87305BD64}"/>
              </c:ext>
            </c:extLst>
          </c:dPt>
          <c:dPt>
            <c:idx val="2"/>
            <c:invertIfNegative val="0"/>
            <c:bubble3D val="0"/>
            <c:spPr>
              <a:solidFill>
                <a:srgbClr val="D9D9D9"/>
              </a:solidFill>
            </c:spPr>
            <c:extLst>
              <c:ext xmlns:c16="http://schemas.microsoft.com/office/drawing/2014/chart" uri="{C3380CC4-5D6E-409C-BE32-E72D297353CC}">
                <c16:uniqueId val="{00000003-51EC-443B-B6BE-4CF87305BD64}"/>
              </c:ext>
            </c:extLst>
          </c:dPt>
          <c:dPt>
            <c:idx val="3"/>
            <c:invertIfNegative val="0"/>
            <c:bubble3D val="0"/>
            <c:spPr>
              <a:solidFill>
                <a:srgbClr val="7F7F7F"/>
              </a:solidFill>
            </c:spPr>
            <c:extLst>
              <c:ext xmlns:c16="http://schemas.microsoft.com/office/drawing/2014/chart" uri="{C3380CC4-5D6E-409C-BE32-E72D297353CC}">
                <c16:uniqueId val="{00000005-51EC-443B-B6BE-4CF87305BD64}"/>
              </c:ext>
            </c:extLst>
          </c:dPt>
          <c:errBars>
            <c:errBarType val="plus"/>
            <c:errValType val="cust"/>
            <c:noEndCap val="0"/>
            <c:plus>
              <c:numRef>
                <c:f>'ALP CM GF Primary vs CL'!$AB$154:$AB$157</c:f>
                <c:numCache>
                  <c:formatCode>General</c:formatCode>
                  <c:ptCount val="4"/>
                  <c:pt idx="0">
                    <c:v>0.16648817802308699</c:v>
                  </c:pt>
                  <c:pt idx="1">
                    <c:v>0.169770673456861</c:v>
                  </c:pt>
                  <c:pt idx="2">
                    <c:v>0.15728962706000599</c:v>
                  </c:pt>
                  <c:pt idx="3">
                    <c:v>0.274449488932217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ALP CM GF Primary vs CL'!$Z$154:$Z$157</c:f>
              <c:strCache>
                <c:ptCount val="4"/>
                <c:pt idx="0">
                  <c:v>GF1</c:v>
                </c:pt>
                <c:pt idx="1">
                  <c:v>GF2</c:v>
                </c:pt>
                <c:pt idx="2">
                  <c:v>GF3</c:v>
                </c:pt>
                <c:pt idx="3">
                  <c:v>GF4</c:v>
                </c:pt>
              </c:strCache>
            </c:strRef>
          </c:cat>
          <c:val>
            <c:numRef>
              <c:f>'ALP CM GF Primary vs CL'!$AA$154:$AA$157</c:f>
              <c:numCache>
                <c:formatCode>General</c:formatCode>
                <c:ptCount val="4"/>
                <c:pt idx="0">
                  <c:v>0.64140714814149702</c:v>
                </c:pt>
                <c:pt idx="1">
                  <c:v>0.2267904390802</c:v>
                </c:pt>
                <c:pt idx="2">
                  <c:v>1.8888362214463501</c:v>
                </c:pt>
                <c:pt idx="3">
                  <c:v>1.1003857385285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1EC-443B-B6BE-4CF87305BD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9748488"/>
        <c:axId val="549754008"/>
      </c:barChart>
      <c:catAx>
        <c:axId val="5497484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Normal media (3 days)</a:t>
                </a:r>
              </a:p>
            </c:rich>
          </c:tx>
          <c:overlay val="0"/>
        </c:title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754008"/>
        <c:crosses val="autoZero"/>
        <c:auto val="1"/>
        <c:lblAlgn val="ctr"/>
        <c:lblOffset val="100"/>
        <c:noMultiLvlLbl val="0"/>
      </c:catAx>
      <c:valAx>
        <c:axId val="54975400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Relative</a:t>
                </a:r>
                <a:r>
                  <a:rPr lang="en-US" sz="1200" baseline="0"/>
                  <a:t> expression</a:t>
                </a:r>
                <a:endParaRPr lang="en-US" sz="120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497484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1400" dirty="0" err="1"/>
              <a:t>Asporin</a:t>
            </a:r>
            <a:endParaRPr lang="en-US" sz="1400" dirty="0"/>
          </a:p>
        </c:rich>
      </c:tx>
      <c:layout>
        <c:manualLayout>
          <c:xMode val="edge"/>
          <c:yMode val="edge"/>
          <c:x val="0.51607121430952096"/>
          <c:y val="4.641297165811990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2917320297744694"/>
          <c:y val="0.30010152380729621"/>
          <c:w val="0.86489657242832296"/>
          <c:h val="0.367836322279980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LAP direct'!$C$162</c:f>
              <c:strCache>
                <c:ptCount val="1"/>
              </c:strCache>
            </c:strRef>
          </c:tx>
          <c:invertIfNegative val="0"/>
          <c:dPt>
            <c:idx val="0"/>
            <c:invertIfNegative val="0"/>
            <c:bubble3D val="0"/>
            <c:spPr>
              <a:pattFill prst="dkDnDiag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1-EC77-4354-9D66-143B4B8CDE01}"/>
              </c:ext>
            </c:extLst>
          </c:dPt>
          <c:dPt>
            <c:idx val="1"/>
            <c:invertIfNegative val="0"/>
            <c:bubble3D val="0"/>
            <c:spPr>
              <a:pattFill prst="dkDnDiag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3-EC77-4354-9D66-143B4B8CDE01}"/>
              </c:ext>
            </c:extLst>
          </c:dPt>
          <c:dPt>
            <c:idx val="2"/>
            <c:invertIfNegative val="0"/>
            <c:bubble3D val="0"/>
            <c:spPr>
              <a:pattFill prst="dkDnDiag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5-EC77-4354-9D66-143B4B8CDE01}"/>
              </c:ext>
            </c:extLst>
          </c:dPt>
          <c:dPt>
            <c:idx val="3"/>
            <c:invertIfNegative val="0"/>
            <c:bubble3D val="0"/>
            <c:spPr>
              <a:pattFill prst="diagBrick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7-EC77-4354-9D66-143B4B8CDE01}"/>
              </c:ext>
            </c:extLst>
          </c:dPt>
          <c:dPt>
            <c:idx val="4"/>
            <c:invertIfNegative val="0"/>
            <c:bubble3D val="0"/>
            <c:spPr>
              <a:pattFill prst="diagBrick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9-EC77-4354-9D66-143B4B8CDE01}"/>
              </c:ext>
            </c:extLst>
          </c:dPt>
          <c:dPt>
            <c:idx val="5"/>
            <c:invertIfNegative val="0"/>
            <c:bubble3D val="0"/>
            <c:spPr>
              <a:pattFill prst="diagBrick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B-EC77-4354-9D66-143B4B8CDE01}"/>
              </c:ext>
            </c:extLst>
          </c:dPt>
          <c:dPt>
            <c:idx val="6"/>
            <c:invertIfNegative val="0"/>
            <c:bubble3D val="0"/>
            <c:spPr>
              <a:pattFill prst="diagBrick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D-EC77-4354-9D66-143B4B8CDE01}"/>
              </c:ext>
            </c:extLst>
          </c:dPt>
          <c:errBars>
            <c:errBarType val="plus"/>
            <c:errValType val="cust"/>
            <c:noEndCap val="0"/>
            <c:plus>
              <c:numRef>
                <c:f>'PLAP direct'!$F$163:$F$169</c:f>
                <c:numCache>
                  <c:formatCode>General</c:formatCode>
                  <c:ptCount val="7"/>
                  <c:pt idx="0">
                    <c:v>3.9316575099580571</c:v>
                  </c:pt>
                  <c:pt idx="1">
                    <c:v>6.5106012750556781</c:v>
                  </c:pt>
                  <c:pt idx="2">
                    <c:v>0.79344345325633103</c:v>
                  </c:pt>
                  <c:pt idx="3">
                    <c:v>0.10830170888178201</c:v>
                  </c:pt>
                  <c:pt idx="4">
                    <c:v>1.4483137971630129</c:v>
                  </c:pt>
                  <c:pt idx="5">
                    <c:v>2.3965510497677749</c:v>
                  </c:pt>
                  <c:pt idx="6">
                    <c:v>0.27285927199529803</c:v>
                  </c:pt>
                </c:numCache>
              </c:numRef>
            </c:plus>
            <c:minus>
              <c:numRef>
                <c:f>'PLAP direct'!$F$163:$F$169</c:f>
                <c:numCache>
                  <c:formatCode>General</c:formatCode>
                  <c:ptCount val="7"/>
                  <c:pt idx="0">
                    <c:v>3.9316575099580571</c:v>
                  </c:pt>
                  <c:pt idx="1">
                    <c:v>6.5106012750556781</c:v>
                  </c:pt>
                  <c:pt idx="2">
                    <c:v>0.79344345325633103</c:v>
                  </c:pt>
                  <c:pt idx="3">
                    <c:v>0.10830170888178201</c:v>
                  </c:pt>
                  <c:pt idx="4">
                    <c:v>1.4483137971630129</c:v>
                  </c:pt>
                  <c:pt idx="5">
                    <c:v>2.3965510497677749</c:v>
                  </c:pt>
                  <c:pt idx="6">
                    <c:v>0.27285927199529803</c:v>
                  </c:pt>
                </c:numCache>
              </c:numRef>
            </c:minus>
          </c:errBars>
          <c:cat>
            <c:strRef>
              <c:f>'PLAP direct'!$B$163:$B$169</c:f>
              <c:strCache>
                <c:ptCount val="7"/>
                <c:pt idx="0">
                  <c:v>Direct culture without sorting</c:v>
                </c:pt>
                <c:pt idx="1">
                  <c:v>single culture PDL without sorting</c:v>
                </c:pt>
                <c:pt idx="2">
                  <c:v>single culture GF without sorting</c:v>
                </c:pt>
                <c:pt idx="3">
                  <c:v>PDL sorting</c:v>
                </c:pt>
                <c:pt idx="4">
                  <c:v>GF sorting</c:v>
                </c:pt>
                <c:pt idx="5">
                  <c:v>single culture PDL with sorting</c:v>
                </c:pt>
                <c:pt idx="6">
                  <c:v>single culture GF with sorting </c:v>
                </c:pt>
              </c:strCache>
            </c:strRef>
          </c:cat>
          <c:val>
            <c:numRef>
              <c:f>'PLAP direct'!$C$163:$C$169</c:f>
              <c:numCache>
                <c:formatCode>General</c:formatCode>
                <c:ptCount val="7"/>
                <c:pt idx="0">
                  <c:v>31.229105284535521</c:v>
                </c:pt>
                <c:pt idx="1">
                  <c:v>30.463848887095409</c:v>
                </c:pt>
                <c:pt idx="2">
                  <c:v>5.7702192966010442</c:v>
                </c:pt>
                <c:pt idx="3">
                  <c:v>0.68523031773141796</c:v>
                </c:pt>
                <c:pt idx="4">
                  <c:v>6.0576252420434864</c:v>
                </c:pt>
                <c:pt idx="5">
                  <c:v>6.6778262888388706</c:v>
                </c:pt>
                <c:pt idx="6">
                  <c:v>0.73984113486473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EC77-4354-9D66-143B4B8CDE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50012024"/>
        <c:axId val="550015112"/>
      </c:barChart>
      <c:catAx>
        <c:axId val="5500120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50015112"/>
        <c:crosses val="autoZero"/>
        <c:auto val="1"/>
        <c:lblAlgn val="ctr"/>
        <c:lblOffset val="100"/>
        <c:noMultiLvlLbl val="0"/>
      </c:catAx>
      <c:valAx>
        <c:axId val="5500151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dirty="0"/>
                  <a:t>Relative</a:t>
                </a:r>
                <a:r>
                  <a:rPr lang="en-US" sz="1200" baseline="0" dirty="0"/>
                  <a:t> expression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5.8865014998333499E-2"/>
              <c:y val="0.186211035031194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5001202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  <c:userShapes r:id="rId3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1400" dirty="0" err="1"/>
              <a:t>Periostin</a:t>
            </a:r>
            <a:endParaRPr lang="en-US" sz="1400" dirty="0"/>
          </a:p>
        </c:rich>
      </c:tx>
      <c:layout>
        <c:manualLayout>
          <c:xMode val="edge"/>
          <c:yMode val="edge"/>
          <c:x val="0.43732699662372698"/>
          <c:y val="1.59132645392342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7331214610805901E-2"/>
          <c:y val="0.18937277578476899"/>
          <c:w val="0.90711790027096795"/>
          <c:h val="0.3875236980837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eriostin direct'!$C$162</c:f>
              <c:strCache>
                <c:ptCount val="1"/>
              </c:strCache>
            </c:strRef>
          </c:tx>
          <c:spPr>
            <a:pattFill prst="dkDnDiag">
              <a:fgClr>
                <a:sysClr val="windowText" lastClr="000000"/>
              </a:fgClr>
              <a:bgClr>
                <a:prstClr val="white"/>
              </a:bgClr>
            </a:patt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20F-4D87-B8A2-3E8847675308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320F-4D87-B8A2-3E8847675308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320F-4D87-B8A2-3E8847675308}"/>
              </c:ext>
            </c:extLst>
          </c:dPt>
          <c:dPt>
            <c:idx val="3"/>
            <c:invertIfNegative val="0"/>
            <c:bubble3D val="0"/>
            <c:spPr>
              <a:pattFill prst="diagBrick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4-320F-4D87-B8A2-3E8847675308}"/>
              </c:ext>
            </c:extLst>
          </c:dPt>
          <c:dPt>
            <c:idx val="4"/>
            <c:invertIfNegative val="0"/>
            <c:bubble3D val="0"/>
            <c:spPr>
              <a:pattFill prst="diagBrick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6-320F-4D87-B8A2-3E8847675308}"/>
              </c:ext>
            </c:extLst>
          </c:dPt>
          <c:dPt>
            <c:idx val="5"/>
            <c:invertIfNegative val="0"/>
            <c:bubble3D val="0"/>
            <c:spPr>
              <a:pattFill prst="diagBrick">
                <a:fgClr>
                  <a:sysClr val="windowText" lastClr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8-320F-4D87-B8A2-3E8847675308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9-320F-4D87-B8A2-3E8847675308}"/>
              </c:ext>
            </c:extLst>
          </c:dPt>
          <c:errBars>
            <c:errBarType val="plus"/>
            <c:errValType val="cust"/>
            <c:noEndCap val="0"/>
            <c:plus>
              <c:numRef>
                <c:f>'Periostin direct'!$F$163:$F$169</c:f>
                <c:numCache>
                  <c:formatCode>General</c:formatCode>
                  <c:ptCount val="7"/>
                  <c:pt idx="0">
                    <c:v>1.2681247337314441</c:v>
                  </c:pt>
                  <c:pt idx="1">
                    <c:v>1.82067052102139</c:v>
                  </c:pt>
                  <c:pt idx="2">
                    <c:v>9.4134782293810101E-2</c:v>
                  </c:pt>
                  <c:pt idx="3">
                    <c:v>0.53788925823045597</c:v>
                  </c:pt>
                  <c:pt idx="4">
                    <c:v>0.38829411029586502</c:v>
                  </c:pt>
                  <c:pt idx="5">
                    <c:v>2.8117114752647421</c:v>
                  </c:pt>
                  <c:pt idx="6">
                    <c:v>5.1530027855435905E-4</c:v>
                  </c:pt>
                </c:numCache>
              </c:numRef>
            </c:plus>
            <c:minus>
              <c:numRef>
                <c:f>'Periostin direct'!$F$163:$F$169</c:f>
                <c:numCache>
                  <c:formatCode>General</c:formatCode>
                  <c:ptCount val="7"/>
                  <c:pt idx="0">
                    <c:v>1.2681247337314441</c:v>
                  </c:pt>
                  <c:pt idx="1">
                    <c:v>1.82067052102139</c:v>
                  </c:pt>
                  <c:pt idx="2">
                    <c:v>9.4134782293810101E-2</c:v>
                  </c:pt>
                  <c:pt idx="3">
                    <c:v>0.53788925823045597</c:v>
                  </c:pt>
                  <c:pt idx="4">
                    <c:v>0.38829411029586502</c:v>
                  </c:pt>
                  <c:pt idx="5">
                    <c:v>2.8117114752647421</c:v>
                  </c:pt>
                  <c:pt idx="6">
                    <c:v>5.1530027855435905E-4</c:v>
                  </c:pt>
                </c:numCache>
              </c:numRef>
            </c:minus>
          </c:errBars>
          <c:cat>
            <c:strRef>
              <c:f>'Periostin direct'!$B$163:$B$169</c:f>
              <c:strCache>
                <c:ptCount val="7"/>
                <c:pt idx="0">
                  <c:v>Direct culture without sorting</c:v>
                </c:pt>
                <c:pt idx="1">
                  <c:v>single culture PDL without sorting</c:v>
                </c:pt>
                <c:pt idx="2">
                  <c:v>single culture GF without sorting</c:v>
                </c:pt>
                <c:pt idx="3">
                  <c:v>PDL sorting</c:v>
                </c:pt>
                <c:pt idx="4">
                  <c:v>GF sorting</c:v>
                </c:pt>
                <c:pt idx="5">
                  <c:v>single culture PDL with sorting</c:v>
                </c:pt>
                <c:pt idx="6">
                  <c:v>single culture GF with sorting </c:v>
                </c:pt>
              </c:strCache>
            </c:strRef>
          </c:cat>
          <c:val>
            <c:numRef>
              <c:f>'Periostin direct'!$C$163:$C$169</c:f>
              <c:numCache>
                <c:formatCode>General</c:formatCode>
                <c:ptCount val="7"/>
                <c:pt idx="0">
                  <c:v>10.94277312524224</c:v>
                </c:pt>
                <c:pt idx="1">
                  <c:v>8.1570330127488209</c:v>
                </c:pt>
                <c:pt idx="2">
                  <c:v>0.628984186686254</c:v>
                </c:pt>
                <c:pt idx="3">
                  <c:v>4.6980156711126346</c:v>
                </c:pt>
                <c:pt idx="4">
                  <c:v>5.2073190601132717</c:v>
                </c:pt>
                <c:pt idx="5">
                  <c:v>11.772549849717169</c:v>
                </c:pt>
                <c:pt idx="6">
                  <c:v>1.7557110004521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20F-4D87-B8A2-3E88476753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50072920"/>
        <c:axId val="550075928"/>
      </c:barChart>
      <c:catAx>
        <c:axId val="5500729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50075928"/>
        <c:crosses val="autoZero"/>
        <c:auto val="1"/>
        <c:lblAlgn val="ctr"/>
        <c:lblOffset val="100"/>
        <c:noMultiLvlLbl val="0"/>
      </c:catAx>
      <c:valAx>
        <c:axId val="5500759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Relative</a:t>
                </a:r>
                <a:r>
                  <a:rPr lang="en-US" sz="1200" baseline="0"/>
                  <a:t> expression</a:t>
                </a:r>
                <a:endParaRPr lang="en-US" sz="1200"/>
              </a:p>
            </c:rich>
          </c:tx>
          <c:layout>
            <c:manualLayout>
              <c:xMode val="edge"/>
              <c:yMode val="edge"/>
              <c:x val="5.6219035926328301E-3"/>
              <c:y val="0.106375435409138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5007292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  <c:userShapes r:id="rId3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baseline="0" dirty="0" err="1"/>
              <a:t>Nestin</a:t>
            </a:r>
            <a:endParaRPr lang="en-US" sz="1400" dirty="0"/>
          </a:p>
        </c:rich>
      </c:tx>
      <c:layout>
        <c:manualLayout>
          <c:xMode val="edge"/>
          <c:yMode val="edge"/>
          <c:x val="0.46056115723091201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4425600646073106E-2"/>
          <c:y val="0.16944444444444401"/>
          <c:w val="0.91350803434638495"/>
          <c:h val="0.509506415864684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estin direct'!$C$162</c:f>
              <c:strCache>
                <c:ptCount val="1"/>
              </c:strCache>
            </c:strRef>
          </c:tx>
          <c:spPr>
            <a:pattFill prst="dkDnDiag">
              <a:fgClr>
                <a:schemeClr val="tx1"/>
              </a:fgClr>
              <a:bgClr>
                <a:prstClr val="white"/>
              </a:bgClr>
            </a:patt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CB62-4B17-AB95-4286A31F6451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CB62-4B17-AB95-4286A31F6451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CB62-4B17-AB95-4286A31F6451}"/>
              </c:ext>
            </c:extLst>
          </c:dPt>
          <c:dPt>
            <c:idx val="3"/>
            <c:invertIfNegative val="0"/>
            <c:bubble3D val="0"/>
            <c:spPr>
              <a:pattFill prst="diagBrick">
                <a:fgClr>
                  <a:schemeClr val="tx1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4-CB62-4B17-AB95-4286A31F6451}"/>
              </c:ext>
            </c:extLst>
          </c:dPt>
          <c:dPt>
            <c:idx val="4"/>
            <c:invertIfNegative val="0"/>
            <c:bubble3D val="0"/>
            <c:spPr>
              <a:pattFill prst="diagBrick">
                <a:fgClr>
                  <a:schemeClr val="tx1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6-CB62-4B17-AB95-4286A31F6451}"/>
              </c:ext>
            </c:extLst>
          </c:dPt>
          <c:dPt>
            <c:idx val="5"/>
            <c:invertIfNegative val="0"/>
            <c:bubble3D val="0"/>
            <c:spPr>
              <a:pattFill prst="diagBrick">
                <a:fgClr>
                  <a:schemeClr val="tx1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8-CB62-4B17-AB95-4286A31F6451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9-CB62-4B17-AB95-4286A31F6451}"/>
              </c:ext>
            </c:extLst>
          </c:dPt>
          <c:errBars>
            <c:errBarType val="plus"/>
            <c:errValType val="cust"/>
            <c:noEndCap val="0"/>
            <c:plus>
              <c:numRef>
                <c:f>'Nestin direct'!$F$163:$F$169</c:f>
                <c:numCache>
                  <c:formatCode>General</c:formatCode>
                  <c:ptCount val="7"/>
                  <c:pt idx="0">
                    <c:v>0.92227296602891595</c:v>
                  </c:pt>
                  <c:pt idx="1">
                    <c:v>0.88600485587206801</c:v>
                  </c:pt>
                  <c:pt idx="2">
                    <c:v>6.2922462335795598E-2</c:v>
                  </c:pt>
                  <c:pt idx="3">
                    <c:v>0.31685350973596599</c:v>
                  </c:pt>
                  <c:pt idx="4">
                    <c:v>0.24632141326589599</c:v>
                  </c:pt>
                  <c:pt idx="5">
                    <c:v>0.32602674297232798</c:v>
                  </c:pt>
                  <c:pt idx="6">
                    <c:v>7.7066965519594494E-2</c:v>
                  </c:pt>
                </c:numCache>
              </c:numRef>
            </c:plus>
            <c:minus>
              <c:numRef>
                <c:f>'Nestin direct'!$F$163:$F$169</c:f>
                <c:numCache>
                  <c:formatCode>General</c:formatCode>
                  <c:ptCount val="7"/>
                  <c:pt idx="0">
                    <c:v>0.92227296602891595</c:v>
                  </c:pt>
                  <c:pt idx="1">
                    <c:v>0.88600485587206801</c:v>
                  </c:pt>
                  <c:pt idx="2">
                    <c:v>6.2922462335795598E-2</c:v>
                  </c:pt>
                  <c:pt idx="3">
                    <c:v>0.31685350973596599</c:v>
                  </c:pt>
                  <c:pt idx="4">
                    <c:v>0.24632141326589599</c:v>
                  </c:pt>
                  <c:pt idx="5">
                    <c:v>0.32602674297232798</c:v>
                  </c:pt>
                  <c:pt idx="6">
                    <c:v>7.7066965519594494E-2</c:v>
                  </c:pt>
                </c:numCache>
              </c:numRef>
            </c:minus>
          </c:errBars>
          <c:cat>
            <c:strRef>
              <c:f>'Nestin direct'!$B$163:$B$169</c:f>
              <c:strCache>
                <c:ptCount val="7"/>
                <c:pt idx="0">
                  <c:v>Direct culture without sorting</c:v>
                </c:pt>
                <c:pt idx="1">
                  <c:v>single culture PDL without sorting</c:v>
                </c:pt>
                <c:pt idx="2">
                  <c:v>single culture GF without sorting</c:v>
                </c:pt>
                <c:pt idx="3">
                  <c:v>PDL sorting</c:v>
                </c:pt>
                <c:pt idx="4">
                  <c:v>GF sorting</c:v>
                </c:pt>
                <c:pt idx="5">
                  <c:v>single culture PDL with sorting</c:v>
                </c:pt>
                <c:pt idx="6">
                  <c:v>single culture GF with sorting </c:v>
                </c:pt>
              </c:strCache>
            </c:strRef>
          </c:cat>
          <c:val>
            <c:numRef>
              <c:f>'Nestin direct'!$C$163:$C$169</c:f>
              <c:numCache>
                <c:formatCode>General</c:formatCode>
                <c:ptCount val="7"/>
                <c:pt idx="0">
                  <c:v>4.3494256595058287</c:v>
                </c:pt>
                <c:pt idx="1">
                  <c:v>1.846660498685281</c:v>
                </c:pt>
                <c:pt idx="2">
                  <c:v>0.28460959465592001</c:v>
                </c:pt>
                <c:pt idx="3">
                  <c:v>1.039024264936419</c:v>
                </c:pt>
                <c:pt idx="4">
                  <c:v>2.5609616916607258</c:v>
                </c:pt>
                <c:pt idx="5">
                  <c:v>1.406973327628636</c:v>
                </c:pt>
                <c:pt idx="6">
                  <c:v>0.391909967950213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CB62-4B17-AB95-4286A31F64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50097400"/>
        <c:axId val="550100408"/>
      </c:barChart>
      <c:catAx>
        <c:axId val="55009740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550100408"/>
        <c:crosses val="autoZero"/>
        <c:auto val="1"/>
        <c:lblAlgn val="ctr"/>
        <c:lblOffset val="100"/>
        <c:noMultiLvlLbl val="0"/>
      </c:catAx>
      <c:valAx>
        <c:axId val="55010040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Relative</a:t>
                </a:r>
                <a:r>
                  <a:rPr lang="en-US" sz="1200" baseline="0"/>
                  <a:t> expression</a:t>
                </a:r>
                <a:endParaRPr lang="en-US" sz="1200"/>
              </a:p>
            </c:rich>
          </c:tx>
          <c:layout>
            <c:manualLayout>
              <c:xMode val="edge"/>
              <c:yMode val="edge"/>
              <c:x val="6.7311552119333502E-3"/>
              <c:y val="0.16481481481481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500974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baseline="0" dirty="0"/>
              <a:t>ALP</a:t>
            </a:r>
            <a:endParaRPr lang="en-US" sz="1400" dirty="0"/>
          </a:p>
        </c:rich>
      </c:tx>
      <c:layout>
        <c:manualLayout>
          <c:xMode val="edge"/>
          <c:yMode val="edge"/>
          <c:x val="0.49256529019845402"/>
          <c:y val="0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LP direct'!$C$162</c:f>
              <c:strCache>
                <c:ptCount val="1"/>
              </c:strCache>
            </c:strRef>
          </c:tx>
          <c:spPr>
            <a:pattFill prst="dkUpDiag">
              <a:fgClr>
                <a:srgbClr val="000000"/>
              </a:fgClr>
              <a:bgClr>
                <a:prstClr val="white"/>
              </a:bgClr>
            </a:patt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0252-4215-A108-7074961C2DB3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0252-4215-A108-7074961C2DB3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0252-4215-A108-7074961C2DB3}"/>
              </c:ext>
            </c:extLst>
          </c:dPt>
          <c:dPt>
            <c:idx val="3"/>
            <c:invertIfNegative val="0"/>
            <c:bubble3D val="0"/>
            <c:spPr>
              <a:pattFill prst="diagBrick">
                <a:fgClr>
                  <a:srgbClr val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4-0252-4215-A108-7074961C2DB3}"/>
              </c:ext>
            </c:extLst>
          </c:dPt>
          <c:dPt>
            <c:idx val="4"/>
            <c:invertIfNegative val="0"/>
            <c:bubble3D val="0"/>
            <c:spPr>
              <a:pattFill prst="diagBrick">
                <a:fgClr>
                  <a:srgbClr val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6-0252-4215-A108-7074961C2DB3}"/>
              </c:ext>
            </c:extLst>
          </c:dPt>
          <c:dPt>
            <c:idx val="5"/>
            <c:invertIfNegative val="0"/>
            <c:bubble3D val="0"/>
            <c:spPr>
              <a:pattFill prst="diagBrick">
                <a:fgClr>
                  <a:srgbClr val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8-0252-4215-A108-7074961C2DB3}"/>
              </c:ext>
            </c:extLst>
          </c:dPt>
          <c:dPt>
            <c:idx val="6"/>
            <c:invertIfNegative val="0"/>
            <c:bubble3D val="0"/>
            <c:spPr>
              <a:pattFill prst="diagBrick">
                <a:fgClr>
                  <a:srgbClr val="000000"/>
                </a:fgClr>
                <a:bgClr>
                  <a:prstClr val="white"/>
                </a:bgClr>
              </a:pattFill>
            </c:spPr>
            <c:extLst>
              <c:ext xmlns:c16="http://schemas.microsoft.com/office/drawing/2014/chart" uri="{C3380CC4-5D6E-409C-BE32-E72D297353CC}">
                <c16:uniqueId val="{0000000A-0252-4215-A108-7074961C2DB3}"/>
              </c:ext>
            </c:extLst>
          </c:dPt>
          <c:errBars>
            <c:errBarType val="plus"/>
            <c:errValType val="cust"/>
            <c:noEndCap val="0"/>
            <c:plus>
              <c:numRef>
                <c:f>'ALP direct'!$F$163:$F$169</c:f>
                <c:numCache>
                  <c:formatCode>General</c:formatCode>
                  <c:ptCount val="7"/>
                  <c:pt idx="0">
                    <c:v>0.13775553702727</c:v>
                  </c:pt>
                  <c:pt idx="1">
                    <c:v>2.9393096166394939</c:v>
                  </c:pt>
                  <c:pt idx="2">
                    <c:v>5.5496059341029101E-2</c:v>
                  </c:pt>
                  <c:pt idx="3">
                    <c:v>6.2848508901108394E-2</c:v>
                  </c:pt>
                  <c:pt idx="4">
                    <c:v>9.1086937300837806E-2</c:v>
                  </c:pt>
                  <c:pt idx="5">
                    <c:v>6.7086599625792206E-2</c:v>
                  </c:pt>
                  <c:pt idx="6">
                    <c:v>7.2886471118360399E-2</c:v>
                  </c:pt>
                </c:numCache>
              </c:numRef>
            </c:plus>
            <c:minus>
              <c:numRef>
                <c:f>'ALP direct'!$F$163:$F$169</c:f>
                <c:numCache>
                  <c:formatCode>General</c:formatCode>
                  <c:ptCount val="7"/>
                  <c:pt idx="0">
                    <c:v>0.13775553702727</c:v>
                  </c:pt>
                  <c:pt idx="1">
                    <c:v>2.9393096166394939</c:v>
                  </c:pt>
                  <c:pt idx="2">
                    <c:v>5.5496059341029101E-2</c:v>
                  </c:pt>
                  <c:pt idx="3">
                    <c:v>6.2848508901108394E-2</c:v>
                  </c:pt>
                  <c:pt idx="4">
                    <c:v>9.1086937300837806E-2</c:v>
                  </c:pt>
                  <c:pt idx="5">
                    <c:v>6.7086599625792206E-2</c:v>
                  </c:pt>
                  <c:pt idx="6">
                    <c:v>7.2886471118360399E-2</c:v>
                  </c:pt>
                </c:numCache>
              </c:numRef>
            </c:minus>
          </c:errBars>
          <c:cat>
            <c:strRef>
              <c:f>'ALP direct'!$B$163:$B$169</c:f>
              <c:strCache>
                <c:ptCount val="7"/>
                <c:pt idx="0">
                  <c:v>Direct culture without sorting</c:v>
                </c:pt>
                <c:pt idx="1">
                  <c:v>single culture PDL without sorting</c:v>
                </c:pt>
                <c:pt idx="2">
                  <c:v>single culture GF without sorting </c:v>
                </c:pt>
                <c:pt idx="3">
                  <c:v>PDL sorting</c:v>
                </c:pt>
                <c:pt idx="4">
                  <c:v>GF sorting</c:v>
                </c:pt>
                <c:pt idx="5">
                  <c:v>single culture PDL with sorting</c:v>
                </c:pt>
                <c:pt idx="6">
                  <c:v>single culture GF with sorting </c:v>
                </c:pt>
              </c:strCache>
            </c:strRef>
          </c:cat>
          <c:val>
            <c:numRef>
              <c:f>'ALP direct'!$C$163:$C$169</c:f>
              <c:numCache>
                <c:formatCode>General</c:formatCode>
                <c:ptCount val="7"/>
                <c:pt idx="0">
                  <c:v>3.9247958246731698</c:v>
                </c:pt>
                <c:pt idx="1">
                  <c:v>10.5994219846606</c:v>
                </c:pt>
                <c:pt idx="2">
                  <c:v>0.64140714814149702</c:v>
                </c:pt>
                <c:pt idx="3">
                  <c:v>0.70139833245156902</c:v>
                </c:pt>
                <c:pt idx="4">
                  <c:v>2.7262664742593361</c:v>
                </c:pt>
                <c:pt idx="5">
                  <c:v>0.41947162654512699</c:v>
                </c:pt>
                <c:pt idx="6">
                  <c:v>0.719716053967861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0252-4215-A108-7074961C2D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50277528"/>
        <c:axId val="550283320"/>
      </c:barChart>
      <c:catAx>
        <c:axId val="5502775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Direct co culture 3 days</a:t>
                </a:r>
                <a:r>
                  <a:rPr lang="en-US" sz="1200" baseline="0"/>
                  <a:t> in normal media</a:t>
                </a:r>
                <a:endParaRPr lang="en-US" sz="1200"/>
              </a:p>
            </c:rich>
          </c:tx>
          <c:overlay val="0"/>
        </c:title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50283320"/>
        <c:crosses val="autoZero"/>
        <c:auto val="1"/>
        <c:lblAlgn val="ctr"/>
        <c:lblOffset val="100"/>
        <c:noMultiLvlLbl val="0"/>
      </c:catAx>
      <c:valAx>
        <c:axId val="55028332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Relative</a:t>
                </a:r>
                <a:r>
                  <a:rPr lang="en-US" sz="1200" baseline="0"/>
                  <a:t> expression</a:t>
                </a:r>
                <a:endParaRPr lang="en-US" sz="120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5502775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118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3">
      <cs:styleClr val="auto"/>
    </cs:fillRef>
    <cs:effectRef idx="2">
      <a:schemeClr val="dk1"/>
    </cs:effectRef>
    <cs:fontRef idx="minor">
      <a:schemeClr val="tx1"/>
    </cs:fontRef>
  </cs:dataPoint>
  <cs:dataPoint3D>
    <cs:lnRef idx="0"/>
    <cs:fillRef idx="3">
      <cs:styleClr val="auto"/>
    </cs:fillRef>
    <cs:effectRef idx="2">
      <a:schemeClr val="dk1"/>
    </cs:effectRef>
    <cs:fontRef idx="minor">
      <a:schemeClr val="tx1"/>
    </cs:fontRef>
  </cs:dataPoint3D>
  <cs:dataPointLine>
    <cs:lnRef idx="1">
      <cs:styleClr val="auto"/>
    </cs:lnRef>
    <cs:lineWidthScale>5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3">
      <cs:styleClr val="auto"/>
    </cs:fillRef>
    <cs:effectRef idx="2">
      <a:schemeClr val="dk1"/>
    </cs:effectRef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0"/>
    <cs:fillRef idx="3">
      <a:schemeClr val="dk1">
        <a:tint val="95000"/>
      </a:schemeClr>
    </cs:fillRef>
    <cs:effectRef idx="2">
      <a:schemeClr val="dk1"/>
    </cs:effectRef>
    <cs:fontRef idx="minor">
      <a:schemeClr val="tx1"/>
    </cs:fontRef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0"/>
    <cs:fillRef idx="3">
      <a:schemeClr val="dk1">
        <a:tint val="5000"/>
      </a:schemeClr>
    </cs:fillRef>
    <cs:effectRef idx="2">
      <a:schemeClr val="dk1"/>
    </cs:effectRef>
    <cs:fontRef idx="minor">
      <a:schemeClr val="tx1"/>
    </cs:fontRef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90504</cdr:x>
      <cdr:y>0.61067</cdr:y>
    </cdr:from>
    <cdr:to>
      <cdr:x>0.98324</cdr:x>
      <cdr:y>0.66372</cdr:y>
    </cdr:to>
    <cdr:sp macro="" textlink="">
      <cdr:nvSpPr>
        <cdr:cNvPr id="13" name="TextBox 12"/>
        <cdr:cNvSpPr txBox="1"/>
      </cdr:nvSpPr>
      <cdr:spPr>
        <a:xfrm xmlns:a="http://schemas.openxmlformats.org/drawingml/2006/main">
          <a:off x="7620539" y="3068329"/>
          <a:ext cx="658462" cy="2665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sz="1800" dirty="0"/>
        </a:p>
      </cdr:txBody>
    </cdr:sp>
  </cdr:relSizeAnchor>
  <cdr:relSizeAnchor xmlns:cdr="http://schemas.openxmlformats.org/drawingml/2006/chartDrawing">
    <cdr:from>
      <cdr:x>0.40062</cdr:x>
      <cdr:y>0.10281</cdr:y>
    </cdr:from>
    <cdr:to>
      <cdr:x>0.47377</cdr:x>
      <cdr:y>0.34111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3605947" y="281333"/>
          <a:ext cx="658423" cy="65206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/>
            <a:t>***</a:t>
          </a:r>
        </a:p>
      </cdr:txBody>
    </cdr:sp>
  </cdr:relSizeAnchor>
  <cdr:relSizeAnchor xmlns:cdr="http://schemas.openxmlformats.org/drawingml/2006/chartDrawing">
    <cdr:from>
      <cdr:x>0.64576</cdr:x>
      <cdr:y>0.22197</cdr:y>
    </cdr:from>
    <cdr:to>
      <cdr:x>0.71891</cdr:x>
      <cdr:y>0.42484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5812486" y="607377"/>
          <a:ext cx="658423" cy="5551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/>
            <a:t>***</a:t>
          </a:r>
        </a:p>
      </cdr:txBody>
    </cdr:sp>
  </cdr:relSizeAnchor>
  <cdr:relSizeAnchor xmlns:cdr="http://schemas.openxmlformats.org/drawingml/2006/chartDrawing">
    <cdr:from>
      <cdr:x>0.52437</cdr:x>
      <cdr:y>0.15168</cdr:y>
    </cdr:from>
    <cdr:to>
      <cdr:x>0.59752</cdr:x>
      <cdr:y>0.43524</cdr:y>
    </cdr:to>
    <cdr:sp macro="" textlink="">
      <cdr:nvSpPr>
        <cdr:cNvPr id="7" name="TextBox 6"/>
        <cdr:cNvSpPr txBox="1"/>
      </cdr:nvSpPr>
      <cdr:spPr>
        <a:xfrm xmlns:a="http://schemas.openxmlformats.org/drawingml/2006/main">
          <a:off x="4719882" y="415044"/>
          <a:ext cx="658423" cy="7759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/>
            <a:t>**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5424</cdr:x>
      <cdr:y>0.10061</cdr:y>
    </cdr:from>
    <cdr:to>
      <cdr:x>0.43173</cdr:x>
      <cdr:y>0.14988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3009999" y="246325"/>
          <a:ext cx="658428" cy="1206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/>
            <a:t>***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4332</cdr:x>
      <cdr:y>0.22735</cdr:y>
    </cdr:from>
    <cdr:to>
      <cdr:x>0.4014</cdr:x>
      <cdr:y>0.22775</cdr:y>
    </cdr:to>
    <cdr:cxnSp macro="">
      <cdr:nvCxnSpPr>
        <cdr:cNvPr id="2" name="Straight Connector 1">
          <a:extLst xmlns:a="http://schemas.openxmlformats.org/drawingml/2006/main">
            <a:ext uri="{FF2B5EF4-FFF2-40B4-BE49-F238E27FC236}">
              <a16:creationId xmlns:a16="http://schemas.microsoft.com/office/drawing/2014/main" id="{5612EDC4-3FF4-4E03-8E31-A69AC931046D}"/>
            </a:ext>
          </a:extLst>
        </cdr:cNvPr>
        <cdr:cNvCxnSpPr/>
      </cdr:nvCxnSpPr>
      <cdr:spPr>
        <a:xfrm xmlns:a="http://schemas.openxmlformats.org/drawingml/2006/main">
          <a:off x="1206771" y="623677"/>
          <a:ext cx="2173059" cy="1097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1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4264</cdr:x>
      <cdr:y>0.29553</cdr:y>
    </cdr:from>
    <cdr:to>
      <cdr:x>0.28969</cdr:x>
      <cdr:y>0.29593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CC675F9A-8558-47CF-83B2-F4C730F02B78}"/>
            </a:ext>
          </a:extLst>
        </cdr:cNvPr>
        <cdr:cNvCxnSpPr/>
      </cdr:nvCxnSpPr>
      <cdr:spPr>
        <a:xfrm xmlns:a="http://schemas.openxmlformats.org/drawingml/2006/main">
          <a:off x="1201043" y="810711"/>
          <a:ext cx="1238176" cy="1097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1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7876</cdr:x>
      <cdr:y>0.9996</cdr:y>
    </cdr:from>
    <cdr:to>
      <cdr:x>0.43684</cdr:x>
      <cdr:y>1</cdr:y>
    </cdr:to>
    <cdr:cxnSp macro="">
      <cdr:nvCxnSpPr>
        <cdr:cNvPr id="5" name="Straight Connector 4">
          <a:extLst xmlns:a="http://schemas.openxmlformats.org/drawingml/2006/main">
            <a:ext uri="{FF2B5EF4-FFF2-40B4-BE49-F238E27FC236}">
              <a16:creationId xmlns:a16="http://schemas.microsoft.com/office/drawing/2014/main" id="{65E408F3-0852-4A85-AE0B-B49C9975CC36}"/>
            </a:ext>
          </a:extLst>
        </cdr:cNvPr>
        <cdr:cNvCxnSpPr/>
      </cdr:nvCxnSpPr>
      <cdr:spPr>
        <a:xfrm xmlns:a="http://schemas.openxmlformats.org/drawingml/2006/main">
          <a:off x="1505140" y="3130527"/>
          <a:ext cx="2173089" cy="1106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4053</cdr:x>
      <cdr:y>0.1561</cdr:y>
    </cdr:from>
    <cdr:to>
      <cdr:x>0.52236</cdr:x>
      <cdr:y>0.15924</cdr:y>
    </cdr:to>
    <cdr:cxnSp macro="">
      <cdr:nvCxnSpPr>
        <cdr:cNvPr id="6" name="Straight Connector 5">
          <a:extLst xmlns:a="http://schemas.openxmlformats.org/drawingml/2006/main">
            <a:ext uri="{FF2B5EF4-FFF2-40B4-BE49-F238E27FC236}">
              <a16:creationId xmlns:a16="http://schemas.microsoft.com/office/drawing/2014/main" id="{9C5FE9F2-DA45-4BBB-A3D6-F78B99FF6BA1}"/>
            </a:ext>
          </a:extLst>
        </cdr:cNvPr>
        <cdr:cNvCxnSpPr/>
      </cdr:nvCxnSpPr>
      <cdr:spPr>
        <a:xfrm xmlns:a="http://schemas.openxmlformats.org/drawingml/2006/main" flipV="1">
          <a:off x="1183283" y="428205"/>
          <a:ext cx="3215046" cy="8612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1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4897</cdr:x>
      <cdr:y>0.19892</cdr:y>
    </cdr:from>
    <cdr:to>
      <cdr:x>0.53163</cdr:x>
      <cdr:y>0.19892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AA7E4604-B6D1-4691-8F51-5117A805CA01}"/>
            </a:ext>
          </a:extLst>
        </cdr:cNvPr>
        <cdr:cNvCxnSpPr/>
      </cdr:nvCxnSpPr>
      <cdr:spPr>
        <a:xfrm xmlns:a="http://schemas.openxmlformats.org/drawingml/2006/main">
          <a:off x="1254321" y="545675"/>
          <a:ext cx="3222046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1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4647</cdr:x>
      <cdr:y>0.29458</cdr:y>
    </cdr:from>
    <cdr:to>
      <cdr:x>0.26489</cdr:x>
      <cdr:y>0.29458</cdr:y>
    </cdr:to>
    <cdr:cxnSp macro="">
      <cdr:nvCxnSpPr>
        <cdr:cNvPr id="5" name="Straight Connector 4">
          <a:extLst xmlns:a="http://schemas.openxmlformats.org/drawingml/2006/main">
            <a:ext uri="{FF2B5EF4-FFF2-40B4-BE49-F238E27FC236}">
              <a16:creationId xmlns:a16="http://schemas.microsoft.com/office/drawing/2014/main" id="{B6C2D96E-4E93-49A6-AF42-BE2D45F2AE3D}"/>
            </a:ext>
          </a:extLst>
        </cdr:cNvPr>
        <cdr:cNvCxnSpPr/>
      </cdr:nvCxnSpPr>
      <cdr:spPr>
        <a:xfrm xmlns:a="http://schemas.openxmlformats.org/drawingml/2006/main">
          <a:off x="1233330" y="808082"/>
          <a:ext cx="997050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2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1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047</cdr:x>
      <cdr:y>0.11474</cdr:y>
    </cdr:from>
    <cdr:to>
      <cdr:x>0.54035</cdr:x>
      <cdr:y>0.17214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4213985" y="314758"/>
          <a:ext cx="335848" cy="1574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400" dirty="0"/>
            <a:t>*</a:t>
          </a:r>
        </a:p>
      </cdr:txBody>
    </cdr:sp>
  </cdr:relSizeAnchor>
  <cdr:relSizeAnchor xmlns:cdr="http://schemas.openxmlformats.org/drawingml/2006/chartDrawing">
    <cdr:from>
      <cdr:x>0.22356</cdr:x>
      <cdr:y>0.20979</cdr:y>
    </cdr:from>
    <cdr:to>
      <cdr:x>0.29854</cdr:x>
      <cdr:y>0.27927</cdr:y>
    </cdr:to>
    <cdr:sp macro="" textlink="">
      <cdr:nvSpPr>
        <cdr:cNvPr id="7" name="TextBox 6"/>
        <cdr:cNvSpPr txBox="1"/>
      </cdr:nvSpPr>
      <cdr:spPr>
        <a:xfrm xmlns:a="http://schemas.openxmlformats.org/drawingml/2006/main">
          <a:off x="1882359" y="575483"/>
          <a:ext cx="631393" cy="1906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/>
            <a:t>**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E2EF1B-0042-C449-9A11-E338AEF8432D}" type="datetimeFigureOut">
              <a:rPr lang="en-US" smtClean="0"/>
              <a:t>5/4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0C8A50-E0B7-7A45-BFCD-5BB280F31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5145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3 day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04C8ED-4F8D-7344-B577-D8B66CEEB64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5416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362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320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028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404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396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757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572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355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704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212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161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AE1C6-3214-DF49-A304-804291FEEBC3}" type="datetimeFigureOut">
              <a:rPr lang="en-US" smtClean="0"/>
              <a:t>5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3A380-E35A-7B4A-B115-8D1276EEC7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607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5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jpeg"/><Relationship Id="rId7" Type="http://schemas.openxmlformats.org/officeDocument/2006/relationships/image" Target="../media/image4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jpe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8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microsoft.com/office/2007/relationships/hdphoto" Target="../media/hdphoto5.wdp"/><Relationship Id="rId7" Type="http://schemas.openxmlformats.org/officeDocument/2006/relationships/image" Target="../media/image10.pn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chart" Target="../charts/char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8032870"/>
              </p:ext>
            </p:extLst>
          </p:nvPr>
        </p:nvGraphicFramePr>
        <p:xfrm>
          <a:off x="4514472" y="58442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7877585"/>
              </p:ext>
            </p:extLst>
          </p:nvPr>
        </p:nvGraphicFramePr>
        <p:xfrm>
          <a:off x="227086" y="58442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86127" y="25752"/>
            <a:ext cx="76547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          </a:t>
            </a:r>
          </a:p>
          <a:p>
            <a:r>
              <a:rPr lang="en-US" dirty="0"/>
              <a:t>					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6B21A71E-ED2E-4F31-8E0F-D5DA927B24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6656293"/>
              </p:ext>
            </p:extLst>
          </p:nvPr>
        </p:nvGraphicFramePr>
        <p:xfrm>
          <a:off x="180710" y="3530375"/>
          <a:ext cx="461837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2583340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1522540"/>
              </p:ext>
            </p:extLst>
          </p:nvPr>
        </p:nvGraphicFramePr>
        <p:xfrm>
          <a:off x="1204817" y="902679"/>
          <a:ext cx="6170623" cy="29536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86127" y="124656"/>
            <a:ext cx="70823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  </a:t>
            </a:r>
          </a:p>
          <a:p>
            <a:r>
              <a:rPr lang="en-US" dirty="0"/>
              <a:t>					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2351054"/>
              </p:ext>
            </p:extLst>
          </p:nvPr>
        </p:nvGraphicFramePr>
        <p:xfrm>
          <a:off x="1408879" y="3890965"/>
          <a:ext cx="588064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1538811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t="5822" r="5181"/>
          <a:stretch/>
        </p:blipFill>
        <p:spPr>
          <a:xfrm>
            <a:off x="3671582" y="0"/>
            <a:ext cx="5404863" cy="5079291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79511" y="116632"/>
            <a:ext cx="3672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285889" y="959454"/>
            <a:ext cx="2614726" cy="2180707"/>
            <a:chOff x="6452087" y="2206361"/>
            <a:chExt cx="2614726" cy="2180707"/>
          </a:xfrm>
        </p:grpSpPr>
        <p:pic>
          <p:nvPicPr>
            <p:cNvPr id="11" name="Picture 2" descr="C:\Users\DFG\Desktop\Composite pdl-gf 1-3 orange 0 day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43000"/>
                      </a14:imgEffect>
                      <a14:imgEffect>
                        <a14:brightnessContrast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52087" y="2206361"/>
              <a:ext cx="2614726" cy="21807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7" name="Straight Connector 16"/>
            <p:cNvCxnSpPr/>
            <p:nvPr/>
          </p:nvCxnSpPr>
          <p:spPr>
            <a:xfrm flipV="1">
              <a:off x="8555515" y="4233135"/>
              <a:ext cx="410534" cy="1282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1"/>
          <p:cNvSpPr txBox="1"/>
          <p:nvPr/>
        </p:nvSpPr>
        <p:spPr>
          <a:xfrm>
            <a:off x="-50349" y="485964"/>
            <a:ext cx="360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311414" y="485964"/>
            <a:ext cx="360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277B7BB-6CAA-4731-AED4-D0711548DB8D}"/>
              </a:ext>
            </a:extLst>
          </p:cNvPr>
          <p:cNvGrpSpPr>
            <a:grpSpLocks noChangeAspect="1"/>
          </p:cNvGrpSpPr>
          <p:nvPr/>
        </p:nvGrpSpPr>
        <p:grpSpPr>
          <a:xfrm>
            <a:off x="606599" y="5253822"/>
            <a:ext cx="6043782" cy="1598395"/>
            <a:chOff x="-1" y="1512946"/>
            <a:chExt cx="9144001" cy="2373843"/>
          </a:xfrm>
        </p:grpSpPr>
        <p:pic>
          <p:nvPicPr>
            <p:cNvPr id="13" name="Picture 12" descr="Screen shot 2020-08-23 at 3.42.20 AM.png">
              <a:extLst>
                <a:ext uri="{FF2B5EF4-FFF2-40B4-BE49-F238E27FC236}">
                  <a16:creationId xmlns:a16="http://schemas.microsoft.com/office/drawing/2014/main" id="{87D4A0FD-C0E7-4F31-9515-DD38FD191CD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35000"/>
                      </a14:imgEffect>
                      <a14:imgEffect>
                        <a14:brightnessContrast bright="7000" contrast="1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" y="1512946"/>
              <a:ext cx="2899395" cy="2373842"/>
            </a:xfrm>
            <a:prstGeom prst="rect">
              <a:avLst/>
            </a:prstGeom>
          </p:spPr>
        </p:pic>
        <p:pic>
          <p:nvPicPr>
            <p:cNvPr id="14" name="Picture 13" descr="Screen shot 2020-08-23 at 3.42.30 AM.png">
              <a:extLst>
                <a:ext uri="{FF2B5EF4-FFF2-40B4-BE49-F238E27FC236}">
                  <a16:creationId xmlns:a16="http://schemas.microsoft.com/office/drawing/2014/main" id="{D9371A37-E095-41CD-8610-FCA5ED84D33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33000"/>
                      </a14:imgEffect>
                      <a14:imgEffect>
                        <a14:brightnessContrast bright="17000" contrast="1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35588" y="1512946"/>
              <a:ext cx="2732615" cy="2373842"/>
            </a:xfrm>
            <a:prstGeom prst="rect">
              <a:avLst/>
            </a:prstGeom>
          </p:spPr>
        </p:pic>
        <p:pic>
          <p:nvPicPr>
            <p:cNvPr id="15" name="Picture 14" descr="Screen shot 2020-08-23 at 3.43.11 AM.png">
              <a:extLst>
                <a:ext uri="{FF2B5EF4-FFF2-40B4-BE49-F238E27FC236}">
                  <a16:creationId xmlns:a16="http://schemas.microsoft.com/office/drawing/2014/main" id="{72C3F03F-7BBD-42B2-A459-2220F1FED99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26000"/>
                      </a14:imgEffect>
                      <a14:imgEffect>
                        <a14:brightnessContrast bright="11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71530" y="1512947"/>
              <a:ext cx="2672470" cy="2373842"/>
            </a:xfrm>
            <a:prstGeom prst="rect">
              <a:avLst/>
            </a:prstGeom>
          </p:spPr>
        </p:pic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16507DF3-0FA1-48DB-976A-1C9B1D7E3C6D}"/>
                </a:ext>
              </a:extLst>
            </p:cNvPr>
            <p:cNvCxnSpPr/>
            <p:nvPr/>
          </p:nvCxnSpPr>
          <p:spPr>
            <a:xfrm flipV="1">
              <a:off x="2386226" y="3668717"/>
              <a:ext cx="410534" cy="1282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3CB5E5F9-A3FC-43E3-8BFA-3EC30993F1D9}"/>
                </a:ext>
              </a:extLst>
            </p:cNvPr>
            <p:cNvCxnSpPr/>
            <p:nvPr/>
          </p:nvCxnSpPr>
          <p:spPr>
            <a:xfrm flipV="1">
              <a:off x="5566315" y="3668717"/>
              <a:ext cx="410534" cy="1282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E16B6F89-8C4C-4976-B622-D6707C8A8EE5}"/>
                </a:ext>
              </a:extLst>
            </p:cNvPr>
            <p:cNvCxnSpPr/>
            <p:nvPr/>
          </p:nvCxnSpPr>
          <p:spPr>
            <a:xfrm flipV="1">
              <a:off x="8630939" y="3655889"/>
              <a:ext cx="410534" cy="1282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9F4C8972-CDCD-4A5B-BC51-2427FAE40E37}"/>
              </a:ext>
            </a:extLst>
          </p:cNvPr>
          <p:cNvSpPr txBox="1"/>
          <p:nvPr/>
        </p:nvSpPr>
        <p:spPr>
          <a:xfrm>
            <a:off x="-990381" y="4940766"/>
            <a:ext cx="89415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    </a:t>
            </a:r>
            <a:r>
              <a:rPr lang="en-US" sz="1400" dirty="0" err="1"/>
              <a:t>Asporin</a:t>
            </a:r>
            <a:r>
              <a:rPr lang="en-US" sz="1400" dirty="0"/>
              <a:t>	                                       </a:t>
            </a:r>
            <a:r>
              <a:rPr lang="en-US" sz="1400" dirty="0" err="1"/>
              <a:t>Periostin</a:t>
            </a:r>
            <a:r>
              <a:rPr lang="en-US" sz="1400" dirty="0"/>
              <a:t>	          	                          </a:t>
            </a:r>
            <a:r>
              <a:rPr lang="en-US" sz="1400" dirty="0" err="1"/>
              <a:t>Nestin</a:t>
            </a:r>
            <a:endParaRPr lang="en-US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412688F-B92B-41BF-B651-5504D4E4E012}"/>
              </a:ext>
            </a:extLst>
          </p:cNvPr>
          <p:cNvSpPr txBox="1"/>
          <p:nvPr/>
        </p:nvSpPr>
        <p:spPr>
          <a:xfrm>
            <a:off x="66347" y="4909988"/>
            <a:ext cx="360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1572431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1639574"/>
              </p:ext>
            </p:extLst>
          </p:nvPr>
        </p:nvGraphicFramePr>
        <p:xfrm>
          <a:off x="-180528" y="-141099"/>
          <a:ext cx="9001000" cy="2736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0185983"/>
              </p:ext>
            </p:extLst>
          </p:nvPr>
        </p:nvGraphicFramePr>
        <p:xfrm>
          <a:off x="352866" y="2404704"/>
          <a:ext cx="8496944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0617386"/>
              </p:ext>
            </p:extLst>
          </p:nvPr>
        </p:nvGraphicFramePr>
        <p:xfrm>
          <a:off x="203009" y="4459594"/>
          <a:ext cx="84201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-29091" y="-48408"/>
            <a:ext cx="3221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4</a:t>
            </a:r>
          </a:p>
        </p:txBody>
      </p:sp>
      <p:cxnSp>
        <p:nvCxnSpPr>
          <p:cNvPr id="3" name="Straight Connector 2"/>
          <p:cNvCxnSpPr>
            <a:cxnSpLocks/>
          </p:cNvCxnSpPr>
          <p:nvPr/>
        </p:nvCxnSpPr>
        <p:spPr>
          <a:xfrm flipV="1">
            <a:off x="1489652" y="332979"/>
            <a:ext cx="2264979" cy="222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489652" y="2868034"/>
            <a:ext cx="2173089" cy="110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253134" y="5059744"/>
            <a:ext cx="658428" cy="120627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**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192175" y="4887799"/>
            <a:ext cx="658428" cy="312305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***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1489652" y="466265"/>
            <a:ext cx="3378916" cy="110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489652" y="661899"/>
            <a:ext cx="4471522" cy="110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1489652" y="3038074"/>
            <a:ext cx="337891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1642052" y="3190474"/>
            <a:ext cx="431912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4539354" y="2847292"/>
            <a:ext cx="658428" cy="120627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***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631960" y="2929453"/>
            <a:ext cx="658428" cy="40472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**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210140" y="4696823"/>
            <a:ext cx="658428" cy="312305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8718975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6069467"/>
              </p:ext>
            </p:extLst>
          </p:nvPr>
        </p:nvGraphicFramePr>
        <p:xfrm>
          <a:off x="592846" y="818840"/>
          <a:ext cx="84201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C53CC5D-3733-4FFD-8B47-5678BC207DFE}"/>
              </a:ext>
            </a:extLst>
          </p:cNvPr>
          <p:cNvSpPr txBox="1"/>
          <p:nvPr/>
        </p:nvSpPr>
        <p:spPr>
          <a:xfrm>
            <a:off x="13301" y="40"/>
            <a:ext cx="3221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4 contd.</a:t>
            </a:r>
          </a:p>
        </p:txBody>
      </p:sp>
    </p:spTree>
    <p:extLst>
      <p:ext uri="{BB962C8B-B14F-4D97-AF65-F5344CB8AC3E}">
        <p14:creationId xmlns:p14="http://schemas.microsoft.com/office/powerpoint/2010/main" val="3988290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5374" y="152625"/>
            <a:ext cx="2328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5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4155631"/>
              </p:ext>
            </p:extLst>
          </p:nvPr>
        </p:nvGraphicFramePr>
        <p:xfrm>
          <a:off x="1222135" y="638917"/>
          <a:ext cx="4716444" cy="1097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4839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6414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0390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56501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rgbClr val="000000"/>
                          </a:solidFill>
                        </a:rPr>
                        <a:t>Co culture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rgbClr val="000000"/>
                          </a:solidFill>
                        </a:rPr>
                        <a:t>PDL only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rgbClr val="000000"/>
                          </a:solidFill>
                        </a:rPr>
                        <a:t>GF only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6501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6501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pSp>
        <p:nvGrpSpPr>
          <p:cNvPr id="21" name="Group 20"/>
          <p:cNvGrpSpPr/>
          <p:nvPr/>
        </p:nvGrpSpPr>
        <p:grpSpPr>
          <a:xfrm>
            <a:off x="1399503" y="1034540"/>
            <a:ext cx="4283518" cy="2493228"/>
            <a:chOff x="1290892" y="1625172"/>
            <a:chExt cx="7075394" cy="4361694"/>
          </a:xfrm>
        </p:grpSpPr>
        <p:pic>
          <p:nvPicPr>
            <p:cNvPr id="5" name="Picture 4" descr="Screen shot 2020-08-23 at 3.54.22 AM.png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7000"/>
                      </a14:imgEffect>
                      <a14:imgEffect>
                        <a14:brightnessContrast contrast="-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0892" y="1625172"/>
              <a:ext cx="2050907" cy="1930390"/>
            </a:xfrm>
            <a:prstGeom prst="rect">
              <a:avLst/>
            </a:prstGeom>
          </p:spPr>
        </p:pic>
        <p:pic>
          <p:nvPicPr>
            <p:cNvPr id="6" name="Picture 5" descr="Screen shot 2020-08-23 at 3.54.46 AM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7260" y="1625172"/>
              <a:ext cx="2059468" cy="1930390"/>
            </a:xfrm>
            <a:prstGeom prst="rect">
              <a:avLst/>
            </a:prstGeom>
          </p:spPr>
        </p:pic>
        <p:pic>
          <p:nvPicPr>
            <p:cNvPr id="7" name="Picture 6" descr="Screen shot 2020-08-23 at 3.54.55 AM.p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06818" y="1625172"/>
              <a:ext cx="2059468" cy="1930390"/>
            </a:xfrm>
            <a:prstGeom prst="rect">
              <a:avLst/>
            </a:prstGeom>
          </p:spPr>
        </p:pic>
        <p:pic>
          <p:nvPicPr>
            <p:cNvPr id="8" name="Picture 7" descr="Screen shot 2020-08-23 at 4.10.29 AM.pn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0892" y="4056476"/>
              <a:ext cx="2019300" cy="1930390"/>
            </a:xfrm>
            <a:prstGeom prst="rect">
              <a:avLst/>
            </a:prstGeom>
          </p:spPr>
        </p:pic>
        <p:pic>
          <p:nvPicPr>
            <p:cNvPr id="9" name="Picture 8" descr="Screen shot 2020-08-23 at 4.10.56 AM.png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7260" y="4056476"/>
              <a:ext cx="2059468" cy="1930390"/>
            </a:xfrm>
            <a:prstGeom prst="rect">
              <a:avLst/>
            </a:prstGeom>
          </p:spPr>
        </p:pic>
        <p:pic>
          <p:nvPicPr>
            <p:cNvPr id="12" name="Picture 11" descr="Screen shot 2020-08-23 at 4.11.25 AM.png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06818" y="4056476"/>
              <a:ext cx="2059468" cy="1930390"/>
            </a:xfrm>
            <a:prstGeom prst="rect">
              <a:avLst/>
            </a:prstGeom>
          </p:spPr>
        </p:pic>
        <p:cxnSp>
          <p:nvCxnSpPr>
            <p:cNvPr id="14" name="Straight Connector 13"/>
            <p:cNvCxnSpPr/>
            <p:nvPr/>
          </p:nvCxnSpPr>
          <p:spPr>
            <a:xfrm>
              <a:off x="3026980" y="3440254"/>
              <a:ext cx="272318" cy="947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5574410" y="3422062"/>
              <a:ext cx="272318" cy="947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8072464" y="3441018"/>
              <a:ext cx="272318" cy="947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3011489" y="5847485"/>
              <a:ext cx="272318" cy="947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5571862" y="5856963"/>
              <a:ext cx="272318" cy="947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8066451" y="5847485"/>
              <a:ext cx="272318" cy="9478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Box 21"/>
          <p:cNvSpPr txBox="1"/>
          <p:nvPr/>
        </p:nvSpPr>
        <p:spPr>
          <a:xfrm>
            <a:off x="361852" y="1345560"/>
            <a:ext cx="11662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rmal Medi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4904" y="2592749"/>
            <a:ext cx="11662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Osteogenic Media 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B650DFC6-F5DE-40B8-A5C3-0EC6B04745BB}"/>
              </a:ext>
            </a:extLst>
          </p:cNvPr>
          <p:cNvGrpSpPr/>
          <p:nvPr/>
        </p:nvGrpSpPr>
        <p:grpSpPr>
          <a:xfrm>
            <a:off x="456156" y="3354253"/>
            <a:ext cx="8215074" cy="4417761"/>
            <a:chOff x="520142" y="3291599"/>
            <a:chExt cx="8215074" cy="4417761"/>
          </a:xfrm>
        </p:grpSpPr>
        <p:graphicFrame>
          <p:nvGraphicFramePr>
            <p:cNvPr id="27" name="Chart 26">
              <a:extLst>
                <a:ext uri="{FF2B5EF4-FFF2-40B4-BE49-F238E27FC236}">
                  <a16:creationId xmlns:a16="http://schemas.microsoft.com/office/drawing/2014/main" id="{561C88A9-EA43-42BA-B0A0-DF2E9D22B82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71844016"/>
                </p:ext>
              </p:extLst>
            </p:nvPr>
          </p:nvGraphicFramePr>
          <p:xfrm>
            <a:off x="520142" y="3291599"/>
            <a:ext cx="8215074" cy="44177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02C43E68-F11B-4652-80D8-B1408143A572}"/>
                </a:ext>
              </a:extLst>
            </p:cNvPr>
            <p:cNvCxnSpPr/>
            <p:nvPr/>
          </p:nvCxnSpPr>
          <p:spPr>
            <a:xfrm>
              <a:off x="2183458" y="4141427"/>
              <a:ext cx="722543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99B5DD31-D3F5-490C-92F4-6F3BBA05A438}"/>
                </a:ext>
              </a:extLst>
            </p:cNvPr>
            <p:cNvCxnSpPr/>
            <p:nvPr/>
          </p:nvCxnSpPr>
          <p:spPr>
            <a:xfrm>
              <a:off x="4476710" y="4237642"/>
              <a:ext cx="722543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1093AEE0-5D7A-4B1B-B1FC-E7FCB968C585}"/>
                </a:ext>
              </a:extLst>
            </p:cNvPr>
            <p:cNvCxnSpPr/>
            <p:nvPr/>
          </p:nvCxnSpPr>
          <p:spPr>
            <a:xfrm>
              <a:off x="6798079" y="4589840"/>
              <a:ext cx="722543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5347ECB-B760-42E2-A410-691024B99791}"/>
                </a:ext>
              </a:extLst>
            </p:cNvPr>
            <p:cNvSpPr txBox="1"/>
            <p:nvPr/>
          </p:nvSpPr>
          <p:spPr>
            <a:xfrm>
              <a:off x="2309947" y="3879385"/>
              <a:ext cx="7225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***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3EA9365-365B-4557-8FDB-AAB19845466E}"/>
                </a:ext>
              </a:extLst>
            </p:cNvPr>
            <p:cNvSpPr txBox="1"/>
            <p:nvPr/>
          </p:nvSpPr>
          <p:spPr>
            <a:xfrm>
              <a:off x="6967143" y="4344839"/>
              <a:ext cx="7225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***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4E8EC08-CF80-47B5-A131-198F9FC90ADF}"/>
                </a:ext>
              </a:extLst>
            </p:cNvPr>
            <p:cNvSpPr txBox="1"/>
            <p:nvPr/>
          </p:nvSpPr>
          <p:spPr>
            <a:xfrm>
              <a:off x="4627679" y="3995902"/>
              <a:ext cx="7225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***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BBEF8EDA-2A99-4518-8817-55526637099F}"/>
              </a:ext>
            </a:extLst>
          </p:cNvPr>
          <p:cNvSpPr txBox="1"/>
          <p:nvPr/>
        </p:nvSpPr>
        <p:spPr>
          <a:xfrm>
            <a:off x="95988" y="588046"/>
            <a:ext cx="360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D64528F-4F66-4089-AA7A-4C79A8F06D1E}"/>
              </a:ext>
            </a:extLst>
          </p:cNvPr>
          <p:cNvSpPr txBox="1"/>
          <p:nvPr/>
        </p:nvSpPr>
        <p:spPr>
          <a:xfrm>
            <a:off x="95988" y="3677512"/>
            <a:ext cx="360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20184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3407</TotalTime>
  <Words>145</Words>
  <Application>Microsoft Macintosh PowerPoint</Application>
  <PresentationFormat>On-screen Show (4:3)</PresentationFormat>
  <Paragraphs>60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 2  J Period Res 2020</dc:title>
  <dc:creator>Devy fire nagarna</dc:creator>
  <cp:lastModifiedBy>Hughes, Francis</cp:lastModifiedBy>
  <cp:revision>100</cp:revision>
  <dcterms:created xsi:type="dcterms:W3CDTF">2020-08-18T18:06:27Z</dcterms:created>
  <dcterms:modified xsi:type="dcterms:W3CDTF">2021-05-04T18:01:28Z</dcterms:modified>
</cp:coreProperties>
</file>